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howGuides="1">
      <p:cViewPr>
        <p:scale>
          <a:sx n="180" d="100"/>
          <a:sy n="180" d="100"/>
        </p:scale>
        <p:origin x="1000" y="-5584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/C:\__sunchung__\__Project_MT_2017\IT_SW\CBF_CRISPER_PROJECT\__Update_070718\__Temp%20vs%20CBFregulon_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/C:\__sunchung__\__Project_MT_2017\IT_SW\CBF_CRISPER_PROJECT\__Update_070718\__Temp%20vs%20CBFregulon_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diamond"/>
            <c:size val="9"/>
            <c:spPr>
              <a:solidFill>
                <a:schemeClr val="tx1"/>
              </a:solidFill>
              <a:ln w="9525">
                <a:noFill/>
                <a:round/>
              </a:ln>
              <a:effectLst/>
            </c:spPr>
          </c:marker>
          <c:dPt>
            <c:idx val="0"/>
            <c:marker>
              <c:spPr>
                <a:solidFill>
                  <a:srgbClr val="FF0000"/>
                </a:solidFill>
                <a:ln w="9525">
                  <a:noFill/>
                  <a:round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E9E8-4FDE-8BC6-01B5A2644A12}"/>
              </c:ext>
            </c:extLst>
          </c:dPt>
          <c:dPt>
            <c:idx val="2"/>
            <c:marker>
              <c:spPr>
                <a:solidFill>
                  <a:schemeClr val="accent1">
                    <a:lumMod val="75000"/>
                  </a:schemeClr>
                </a:solidFill>
                <a:ln w="9525">
                  <a:noFill/>
                  <a:round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E9E8-4FDE-8BC6-01B5A2644A12}"/>
              </c:ext>
            </c:extLst>
          </c:dPt>
          <c:trendline>
            <c:spPr>
              <a:ln w="9525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3.2015925545538691E-2"/>
                  <c:y val="-0.5222707679832704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vert="horz"/>
                <a:lstStyle/>
                <a:p>
                  <a:pPr>
                    <a:defRPr/>
                  </a:pPr>
                  <a:endParaRPr lang="en-US"/>
                </a:p>
              </c:txPr>
            </c:trendlineLbl>
          </c:trendline>
          <c:xVal>
            <c:numRef>
              <c:f>'newMinimum (2)'!$B$2:$B$4</c:f>
              <c:numCache>
                <c:formatCode>General</c:formatCode>
                <c:ptCount val="3"/>
                <c:pt idx="0">
                  <c:v>126</c:v>
                </c:pt>
                <c:pt idx="1">
                  <c:v>321</c:v>
                </c:pt>
                <c:pt idx="2">
                  <c:v>471</c:v>
                </c:pt>
              </c:numCache>
            </c:numRef>
          </c:xVal>
          <c:yVal>
            <c:numRef>
              <c:f>'newMinimum (2)'!$C$2:$C$4</c:f>
              <c:numCache>
                <c:formatCode>General</c:formatCode>
                <c:ptCount val="3"/>
                <c:pt idx="0">
                  <c:v>2.7</c:v>
                </c:pt>
                <c:pt idx="1">
                  <c:v>-5</c:v>
                </c:pt>
                <c:pt idx="2">
                  <c:v>-12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99A-4100-B9BD-FA42A12B6B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872704"/>
        <c:axId val="51661056"/>
      </c:scatterChart>
      <c:valAx>
        <c:axId val="32872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51661056"/>
        <c:crossesAt val="-15"/>
        <c:crossBetween val="midCat"/>
      </c:valAx>
      <c:valAx>
        <c:axId val="51661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328727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 w="9525" cap="flat" cmpd="sng" algn="ctr">
      <a:noFill/>
      <a:round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diamond"/>
            <c:size val="9"/>
            <c:spPr>
              <a:solidFill>
                <a:schemeClr val="tx1"/>
              </a:solidFill>
              <a:ln w="9525">
                <a:noFill/>
                <a:round/>
              </a:ln>
              <a:effectLst/>
            </c:spPr>
          </c:marker>
          <c:dPt>
            <c:idx val="0"/>
            <c:marker>
              <c:spPr>
                <a:solidFill>
                  <a:srgbClr val="FF0000"/>
                </a:solidFill>
                <a:ln w="9525">
                  <a:noFill/>
                  <a:round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1F35-441C-828D-2A3BD5B5B0BB}"/>
              </c:ext>
            </c:extLst>
          </c:dPt>
          <c:dPt>
            <c:idx val="2"/>
            <c:marker>
              <c:spPr>
                <a:solidFill>
                  <a:schemeClr val="accent1">
                    <a:lumMod val="75000"/>
                  </a:schemeClr>
                </a:solidFill>
                <a:ln w="9525">
                  <a:noFill/>
                  <a:round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1F35-441C-828D-2A3BD5B5B0BB}"/>
              </c:ext>
            </c:extLst>
          </c:dPt>
          <c:trendline>
            <c:spPr>
              <a:ln w="9525" cap="rnd">
                <a:solidFill>
                  <a:schemeClr val="tx1"/>
                </a:solidFill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22267987561337441"/>
                  <c:y val="-0.5562549345965900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vert="horz"/>
                <a:lstStyle/>
                <a:p>
                  <a:pPr>
                    <a:defRPr/>
                  </a:pPr>
                  <a:endParaRPr lang="en-US"/>
                </a:p>
              </c:txPr>
            </c:trendlineLbl>
          </c:trendline>
          <c:xVal>
            <c:numRef>
              <c:f>'newMinimum (2)'!$B$8:$B$10</c:f>
              <c:numCache>
                <c:formatCode>General</c:formatCode>
                <c:ptCount val="3"/>
                <c:pt idx="0">
                  <c:v>1680</c:v>
                </c:pt>
                <c:pt idx="1">
                  <c:v>1953</c:v>
                </c:pt>
                <c:pt idx="2">
                  <c:v>2463</c:v>
                </c:pt>
              </c:numCache>
            </c:numRef>
          </c:xVal>
          <c:yVal>
            <c:numRef>
              <c:f>'newMinimum (2)'!$C$8:$C$10</c:f>
              <c:numCache>
                <c:formatCode>General</c:formatCode>
                <c:ptCount val="3"/>
                <c:pt idx="0">
                  <c:v>2.7</c:v>
                </c:pt>
                <c:pt idx="1">
                  <c:v>-5</c:v>
                </c:pt>
                <c:pt idx="2">
                  <c:v>-12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F35-441C-828D-2A3BD5B5B0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051840"/>
        <c:axId val="38052992"/>
      </c:scatterChart>
      <c:valAx>
        <c:axId val="380518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38052992"/>
        <c:crossesAt val="-15"/>
        <c:crossBetween val="midCat"/>
      </c:valAx>
      <c:valAx>
        <c:axId val="380529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380518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 w="9525" cap="flat" cmpd="sng" algn="ctr">
      <a:noFill/>
      <a:round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917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272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837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523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092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607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371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27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805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383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642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7E4BF3-BD49-4C33-B4C3-EA5D55C24D3A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D78CA-D166-44C0-947D-26FA40B928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553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Chart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1805983"/>
              </p:ext>
            </p:extLst>
          </p:nvPr>
        </p:nvGraphicFramePr>
        <p:xfrm>
          <a:off x="1239654" y="5031866"/>
          <a:ext cx="2860243" cy="2061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8" name="Chart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4780353"/>
              </p:ext>
            </p:extLst>
          </p:nvPr>
        </p:nvGraphicFramePr>
        <p:xfrm>
          <a:off x="3943788" y="5028341"/>
          <a:ext cx="2860243" cy="2061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0" name="TextBox 29"/>
          <p:cNvSpPr txBox="1"/>
          <p:nvPr/>
        </p:nvSpPr>
        <p:spPr>
          <a:xfrm>
            <a:off x="2642616" y="1089661"/>
            <a:ext cx="2884372" cy="302932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Cold-Induced CBF regulon Genes</a:t>
            </a:r>
          </a:p>
        </p:txBody>
      </p:sp>
      <p:grpSp>
        <p:nvGrpSpPr>
          <p:cNvPr id="31" name="Group 30"/>
          <p:cNvGrpSpPr/>
          <p:nvPr/>
        </p:nvGrpSpPr>
        <p:grpSpPr>
          <a:xfrm>
            <a:off x="2749761" y="1689489"/>
            <a:ext cx="2279904" cy="2212848"/>
            <a:chOff x="789704" y="1458172"/>
            <a:chExt cx="2369378" cy="2342099"/>
          </a:xfrm>
        </p:grpSpPr>
        <p:grpSp>
          <p:nvGrpSpPr>
            <p:cNvPr id="32" name="Group 31"/>
            <p:cNvGrpSpPr/>
            <p:nvPr/>
          </p:nvGrpSpPr>
          <p:grpSpPr>
            <a:xfrm>
              <a:off x="789704" y="1458172"/>
              <a:ext cx="2369378" cy="2342099"/>
              <a:chOff x="685800" y="2438400"/>
              <a:chExt cx="2628900" cy="2598633"/>
            </a:xfrm>
          </p:grpSpPr>
          <p:sp>
            <p:nvSpPr>
              <p:cNvPr id="40" name="Oval 39"/>
              <p:cNvSpPr/>
              <p:nvPr/>
            </p:nvSpPr>
            <p:spPr>
              <a:xfrm>
                <a:off x="685800" y="2438400"/>
                <a:ext cx="1752600" cy="1752600"/>
              </a:xfrm>
              <a:prstGeom prst="ellipse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" name="Oval 40"/>
              <p:cNvSpPr/>
              <p:nvPr/>
            </p:nvSpPr>
            <p:spPr>
              <a:xfrm>
                <a:off x="1562100" y="2453640"/>
                <a:ext cx="1752600" cy="1752600"/>
              </a:xfrm>
              <a:prstGeom prst="ellipse">
                <a:avLst/>
              </a:prstGeom>
              <a:noFill/>
              <a:ln w="28575">
                <a:solidFill>
                  <a:schemeClr val="accent1"/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" name="Oval 41"/>
              <p:cNvSpPr/>
              <p:nvPr/>
            </p:nvSpPr>
            <p:spPr>
              <a:xfrm>
                <a:off x="1130876" y="3284434"/>
                <a:ext cx="1752600" cy="1752599"/>
              </a:xfrm>
              <a:prstGeom prst="ellipse">
                <a:avLst/>
              </a:prstGeom>
              <a:noFill/>
              <a:ln w="28575">
                <a:solidFill>
                  <a:schemeClr val="accent2"/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3" name="TextBox 32"/>
            <p:cNvSpPr txBox="1"/>
            <p:nvPr/>
          </p:nvSpPr>
          <p:spPr>
            <a:xfrm>
              <a:off x="1774694" y="1837340"/>
              <a:ext cx="385159" cy="3094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solidFill>
                    <a:srgbClr val="33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769104" y="2346678"/>
              <a:ext cx="385159" cy="3094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482976" y="2024765"/>
              <a:ext cx="481781" cy="3094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334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222241" y="2601460"/>
              <a:ext cx="385159" cy="3094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solidFill>
                    <a:srgbClr val="33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774694" y="3224963"/>
              <a:ext cx="385159" cy="3094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319676" y="2605725"/>
              <a:ext cx="385159" cy="3094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solidFill>
                    <a:srgbClr val="33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939938" y="2023206"/>
              <a:ext cx="481781" cy="3094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169</a:t>
              </a:r>
            </a:p>
          </p:txBody>
        </p:sp>
      </p:grpSp>
      <p:sp>
        <p:nvSpPr>
          <p:cNvPr id="44" name="TextBox 43"/>
          <p:cNvSpPr txBox="1"/>
          <p:nvPr/>
        </p:nvSpPr>
        <p:spPr>
          <a:xfrm>
            <a:off x="1649476" y="1555123"/>
            <a:ext cx="1243012" cy="507832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pPr algn="ctr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Col-0 </a:t>
            </a:r>
          </a:p>
          <a:p>
            <a:pPr algn="ctr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(321 of 1953)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862068" y="1555123"/>
            <a:ext cx="1243012" cy="507832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pPr algn="ctr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W </a:t>
            </a:r>
          </a:p>
          <a:p>
            <a:pPr algn="ctr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(471 of 2463)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3273044" y="3935611"/>
            <a:ext cx="1243012" cy="507832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pPr algn="ctr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IT </a:t>
            </a:r>
          </a:p>
          <a:p>
            <a:pPr algn="ctr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(126 of 1680)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297176" y="1005841"/>
            <a:ext cx="334644" cy="304699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218917" y="4731042"/>
            <a:ext cx="334644" cy="304699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693540" y="7035165"/>
            <a:ext cx="2302847" cy="270843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umber of CBF regulon genes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923395" y="4731042"/>
            <a:ext cx="334644" cy="304699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645974" y="7030225"/>
            <a:ext cx="1775062" cy="270843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umber of COR genes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112008" y="5733763"/>
            <a:ext cx="1909318" cy="453458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inimum average monthly temperature (</a:t>
            </a:r>
            <a:r>
              <a:rPr lang="en-US" sz="11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49072" y="7834376"/>
            <a:ext cx="6874256" cy="1726626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 Fig. The CBF regulons of the IT, SW, and Col-0 genotypes are composed of conserved and specific genes. (A)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nn diagram showing the number of common and specific CBF regulon genes.  Genes were assigned to the CBF regulon if they were induced at least two-fold in response to low temperature (4°C for 24 h) and down-regulated in the </a:t>
            </a:r>
            <a:r>
              <a:rPr lang="en-US" sz="13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f123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iple mutant by at least two-fold (log</a:t>
            </a:r>
            <a:r>
              <a:rPr lang="en-US" sz="13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, FDR = 0.05).  (B, C) The average minimum monthly temperatures for the genotypes were plotted against the number of CBF regulon genes (B) or total number of COR genes (C).  A regression line for the data and R</a:t>
            </a:r>
            <a:r>
              <a:rPr lang="en-US" sz="13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 are shown. Red indicates it:</a:t>
            </a:r>
            <a:r>
              <a:rPr lang="en-US" sz="13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f123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black, col:</a:t>
            </a:r>
            <a:r>
              <a:rPr lang="en-US" sz="13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f123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blue, sw:</a:t>
            </a:r>
            <a:r>
              <a:rPr lang="en-US" sz="13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f123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0964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98</Words>
  <Application>Microsoft Macintosh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lmour, Sarah</dc:creator>
  <cp:lastModifiedBy>Thomashow, Michael</cp:lastModifiedBy>
  <cp:revision>4</cp:revision>
  <dcterms:created xsi:type="dcterms:W3CDTF">2018-07-27T15:11:02Z</dcterms:created>
  <dcterms:modified xsi:type="dcterms:W3CDTF">2018-11-09T14:27:39Z</dcterms:modified>
</cp:coreProperties>
</file>